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1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2238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4869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9498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6738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015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0486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9335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4069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281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60483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9263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5957A-C70B-4B08-B93F-A752DA7EA82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C1BC9-B47E-4E1C-BEF5-8439D5602D5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4190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6905961"/>
              </p:ext>
            </p:extLst>
          </p:nvPr>
        </p:nvGraphicFramePr>
        <p:xfrm>
          <a:off x="47625" y="1028699"/>
          <a:ext cx="9020176" cy="4134554"/>
        </p:xfrm>
        <a:graphic>
          <a:graphicData uri="http://schemas.openxmlformats.org/drawingml/2006/table">
            <a:tbl>
              <a:tblPr/>
              <a:tblGrid>
                <a:gridCol w="1052519"/>
                <a:gridCol w="2204767"/>
                <a:gridCol w="2355268"/>
                <a:gridCol w="1753923"/>
                <a:gridCol w="1653699"/>
              </a:tblGrid>
              <a:tr h="4857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ker name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 sequence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´ to 3´)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sequence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´ to 3´)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cted</a:t>
                      </a:r>
                      <a:r>
                        <a:rPr lang="en-US" sz="1000" b="0" i="0" u="none" strike="noStrike" baseline="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oduct size for N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ponbare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p)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cted</a:t>
                      </a:r>
                      <a:r>
                        <a:rPr lang="en-US" sz="1000" b="0" i="0" u="none" strike="noStrike" baseline="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oduct size for 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p)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0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AGCTCAGAATGTGCTCA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GCTATCAACTGTCGAG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0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CATCCCATGAATGCT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GGGTCTAGCTAGGTTAC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0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CTCTACATGCCCTCGTC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GTGTGTTGGTAGGTCAGA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0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TGTTCCGGTGGACTCA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AGAATGCACCCCATGTTC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0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GGCGACGTTAGCTTAAA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AAGCCAGAGCAGCATG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0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CGTCCACTCACGAAATG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AGTATATAGTTCGTACGCAC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1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CTGCATGTGAGGACAA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GTTCCTGTAACGCATC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1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CCACAAAAGGCAGTTG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GGTCCAAGGTGTGCAT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1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CCATTTTTCAATTCTAC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AAACCACCATGCCGTT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1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TGGGTATTCTTCCAGAC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AGTTTTTGGCGGGCTA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1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AATGTTTGGTCACCATCC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AGTCTCCTGCAATATCCC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1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GTTGTAGGTTGCCGTT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GCAAGCTACTGTTTTAG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2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TGCATCTGCATCACTGC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CTGACCAACCTGTTT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0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08-2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TTTCCTTCTTCCACC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CTGGCATTGAAGAGTT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Title 1"/>
          <p:cNvSpPr txBox="1"/>
          <p:nvPr/>
        </p:nvSpPr>
        <p:spPr>
          <a:xfrm>
            <a:off x="0" y="656543"/>
            <a:ext cx="8043787" cy="241047"/>
          </a:xfrm>
          <a:prstGeom prst="rect">
            <a:avLst/>
          </a:prstGeom>
        </p:spPr>
        <p:txBody>
          <a:bodyPr vert="horz" lIns="91426" tIns="45713" rIns="91426" bIns="45713" rtlCol="0" anchor="ctr">
            <a:noAutofit/>
          </a:bodyPr>
          <a:lstStyle/>
          <a:p>
            <a:pPr algn="just">
              <a:spcAft>
                <a:spcPts val="1000"/>
              </a:spcAft>
            </a:pPr>
            <a:r>
              <a:rPr lang="en-US" alt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2: 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able S2 </a:t>
            </a:r>
            <a:r>
              <a:rPr lang="en-US" sz="1200" dirty="0">
                <a:latin typeface="Times New Roman" panose="02020603050405020304"/>
                <a:ea typeface="Calibri" panose="020F0502020204030204"/>
                <a:cs typeface="Times New Roman" panose="02020603050405020304"/>
              </a:rPr>
              <a:t>List of newly designed polymorphic InDel markers with their sequence and product sizes</a:t>
            </a:r>
            <a:endParaRPr kumimoji="0" lang="en-US" sz="12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7734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On-screen Show 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28:48Z</dcterms:created>
  <dcterms:modified xsi:type="dcterms:W3CDTF">2021-09-02T09:29:06Z</dcterms:modified>
</cp:coreProperties>
</file>